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516" y="4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963" name="Group 67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4097683"/>
              </p:ext>
            </p:extLst>
          </p:nvPr>
        </p:nvGraphicFramePr>
        <p:xfrm>
          <a:off x="900113" y="1124745"/>
          <a:ext cx="7272340" cy="4280715"/>
        </p:xfrm>
        <a:graphic>
          <a:graphicData uri="http://schemas.openxmlformats.org/drawingml/2006/table">
            <a:tbl>
              <a:tblPr/>
              <a:tblGrid>
                <a:gridCol w="348684"/>
                <a:gridCol w="573845"/>
                <a:gridCol w="348685"/>
                <a:gridCol w="278322"/>
                <a:gridCol w="350249"/>
                <a:gridCol w="348684"/>
                <a:gridCol w="348685"/>
                <a:gridCol w="348684"/>
                <a:gridCol w="139162"/>
                <a:gridCol w="322103"/>
                <a:gridCol w="322103"/>
                <a:gridCol w="322103"/>
                <a:gridCol w="322103"/>
                <a:gridCol w="322103"/>
                <a:gridCol w="343994"/>
                <a:gridCol w="209523"/>
                <a:gridCol w="412793"/>
                <a:gridCol w="322103"/>
                <a:gridCol w="322103"/>
                <a:gridCol w="322103"/>
                <a:gridCol w="322103"/>
                <a:gridCol w="322103"/>
              </a:tblGrid>
              <a:tr h="194151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Pair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Sample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KOH-extractable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Non-KOH-extractable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otal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79666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H/G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H/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S/G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H/G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H/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S/G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H/G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H/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S/G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48992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-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27(H)</a:t>
                      </a:r>
                      <a:r>
                        <a:rPr kumimoji="0" lang="zh-CN" altLang="en-US" sz="1200" b="1" i="0" u="none" strike="noStrike" cap="none" normalizeH="0" baseline="3000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sym typeface="宋体" pitchFamily="2" charset="-122"/>
                        </a:rPr>
                        <a:t>&amp;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61%</a:t>
                      </a:r>
                      <a:r>
                        <a:rPr kumimoji="0" lang="en-US" altLang="zh-CN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*</a:t>
                      </a: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4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8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6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8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26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6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0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4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5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483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98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8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98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5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1919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-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1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86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73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7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1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7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95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3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71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4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2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2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47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5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48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8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6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8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6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1919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-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107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4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67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38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2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9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0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0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6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9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23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5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03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7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0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93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5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8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5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6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9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5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1919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1919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I-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1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2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7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4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4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95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5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5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4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2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5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71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4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0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1919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I-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107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4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44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32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29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41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0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5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9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42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5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43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7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58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9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9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09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6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7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1919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I-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46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4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9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7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11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0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9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8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9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3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9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2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47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5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48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8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6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8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6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1919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1919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II-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Osfc27</a:t>
                      </a: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8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67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38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33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9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0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9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92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6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138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6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44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8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18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4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76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9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12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71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4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0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1919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II-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Osfc2</a:t>
                      </a: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9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49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5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21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9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0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8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37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6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71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8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41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8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35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48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15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9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85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48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4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99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6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6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1919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II-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Osfc32</a:t>
                      </a: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9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23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5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44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3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99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17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8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194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52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9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59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5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93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-7%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899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27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2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4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6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1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3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0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31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65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12841" name="Rectangle 671"/>
          <p:cNvSpPr>
            <a:spLocks noGrp="1" noChangeArrowheads="1"/>
          </p:cNvSpPr>
          <p:nvPr>
            <p:ph type="title"/>
          </p:nvPr>
        </p:nvSpPr>
        <p:spPr>
          <a:xfrm>
            <a:off x="827088" y="908720"/>
            <a:ext cx="3311525" cy="228600"/>
          </a:xfrm>
        </p:spPr>
        <p:txBody>
          <a:bodyPr>
            <a:noAutofit/>
          </a:bodyPr>
          <a:lstStyle/>
          <a:p>
            <a:pPr algn="l"/>
            <a:r>
              <a:rPr lang="zh-CN" altLang="en-US" sz="1000" b="1" dirty="0" smtClean="0">
                <a:latin typeface="Arial" pitchFamily="34" charset="0"/>
                <a:cs typeface="Arial" pitchFamily="34" charset="0"/>
              </a:rPr>
              <a:t>Table S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5</a:t>
            </a:r>
            <a:r>
              <a:rPr lang="zh-CN" altLang="en-US" sz="10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zh-CN" altLang="en-U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Ratios of three </a:t>
            </a:r>
            <a:r>
              <a:rPr lang="en-US" altLang="zh-CN" sz="1000" dirty="0" err="1" smtClean="0">
                <a:latin typeface="Arial" pitchFamily="34" charset="0"/>
                <a:cs typeface="Arial" pitchFamily="34" charset="0"/>
              </a:rPr>
              <a:t>monolignins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  </a:t>
            </a:r>
            <a:endParaRPr lang="zh-CN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105" name="Rectangle 1457"/>
          <p:cNvSpPr>
            <a:spLocks noChangeArrowheads="1"/>
          </p:cNvSpPr>
          <p:nvPr/>
        </p:nvSpPr>
        <p:spPr bwMode="auto">
          <a:xfrm>
            <a:off x="828675" y="5415607"/>
            <a:ext cx="656622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GB" altLang="en-US" sz="1400" b="1" baseline="30000" dirty="0">
                <a:latin typeface="Arial" pitchFamily="34" charset="0"/>
                <a:cs typeface="Arial" pitchFamily="34" charset="0"/>
                <a:sym typeface="宋体" pitchFamily="2" charset="-122"/>
              </a:rPr>
              <a:t>&amp;</a:t>
            </a:r>
            <a:r>
              <a:rPr lang="en-US" altLang="zh-CN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, </a:t>
            </a:r>
            <a:r>
              <a:rPr lang="zh-CN" altLang="en-US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(H) or (L) Indicated the sample in the pair with high (H) or low (L)  biomass digestibility</a:t>
            </a:r>
            <a:r>
              <a:rPr lang="en-US" altLang="zh-CN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;</a:t>
            </a:r>
            <a:endParaRPr lang="zh-CN" altLang="en-US" sz="1000" baseline="0" dirty="0">
              <a:latin typeface="Arial" pitchFamily="34" charset="0"/>
              <a:cs typeface="Arial" pitchFamily="34" charset="0"/>
              <a:sym typeface="宋体" pitchFamily="2" charset="-122"/>
            </a:endParaRPr>
          </a:p>
          <a:p>
            <a:pPr>
              <a:defRPr/>
            </a:pPr>
            <a:r>
              <a:rPr lang="zh-CN" altLang="en-US" sz="1400" b="1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*</a:t>
            </a:r>
            <a:r>
              <a:rPr lang="en-US" altLang="zh-CN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,</a:t>
            </a:r>
            <a:r>
              <a:rPr lang="en-GB" altLang="zh-CN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altLang="zh-CN" sz="1000" baseline="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P</a:t>
            </a:r>
            <a:r>
              <a:rPr lang="en-GB" altLang="en-US" sz="1000" baseline="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rcentage </a:t>
            </a:r>
            <a:r>
              <a:rPr lang="en-GB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of the increased or decreased level at pair: subtraction of two samples divided by </a:t>
            </a:r>
            <a:r>
              <a:rPr lang="zh-CN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ow </a:t>
            </a:r>
            <a:r>
              <a:rPr lang="en-GB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value at pair</a:t>
            </a:r>
            <a:r>
              <a:rPr lang="zh-CN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9671751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6</Words>
  <Application>Microsoft Office PowerPoint</Application>
  <PresentationFormat>全屏显示(4:3)</PresentationFormat>
  <Paragraphs>28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Table S5.  Ratios of three monolignins  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S5.  Ratios of three monolignins  </dc:title>
  <cp:lastModifiedBy>微软用户</cp:lastModifiedBy>
  <cp:revision>4</cp:revision>
  <dcterms:modified xsi:type="dcterms:W3CDTF">2013-09-04T07:31:01Z</dcterms:modified>
</cp:coreProperties>
</file>